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0004"/>
    <a:srgbClr val="4543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283" autoAdjust="0"/>
    <p:restoredTop sz="94660"/>
  </p:normalViewPr>
  <p:slideViewPr>
    <p:cSldViewPr snapToGrid="0">
      <p:cViewPr>
        <p:scale>
          <a:sx n="125" d="100"/>
          <a:sy n="125" d="100"/>
        </p:scale>
        <p:origin x="-442" y="-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783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467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04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35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43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281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268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433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34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105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396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B1899-A879-4602-93D0-0A9D48654241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57AB6-E2AE-4848-8D7F-E14D66C2B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604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7C598D75-7DDD-4747-AAEC-852E9CBE2063}"/>
              </a:ext>
            </a:extLst>
          </p:cNvPr>
          <p:cNvGrpSpPr/>
          <p:nvPr/>
        </p:nvGrpSpPr>
        <p:grpSpPr>
          <a:xfrm>
            <a:off x="3158181" y="2089415"/>
            <a:ext cx="57428" cy="2626100"/>
            <a:chOff x="1483768" y="2181778"/>
            <a:chExt cx="52892" cy="2626100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FAF21D53-7EE6-A34A-812B-101383B9C9BE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4807878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565916AE-683A-634C-8CE3-8819E6706900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4370193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616C18BF-6C02-EA4B-BB9B-816B846E5829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3494827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DB31A67D-173C-974E-B0C3-3592FE2C8E78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2181778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AB63E73A-2573-CB4D-B722-3CE05B2B4D02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3932510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00CBA83F-0E69-5142-ACA3-A131ED03BCDC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2619461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30C4124F-CD2E-F848-87CB-C91EEB8ED888}"/>
                </a:ext>
              </a:extLst>
            </p:cNvPr>
            <p:cNvCxnSpPr>
              <a:cxnSpLocks/>
            </p:cNvCxnSpPr>
            <p:nvPr/>
          </p:nvCxnSpPr>
          <p:spPr>
            <a:xfrm>
              <a:off x="1483768" y="3057144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588C9BD6-76A9-9A40-ADFA-4FA48AF67A27}"/>
              </a:ext>
            </a:extLst>
          </p:cNvPr>
          <p:cNvGrpSpPr/>
          <p:nvPr/>
        </p:nvGrpSpPr>
        <p:grpSpPr>
          <a:xfrm>
            <a:off x="2780146" y="2033049"/>
            <a:ext cx="334856" cy="2743570"/>
            <a:chOff x="1135593" y="2125412"/>
            <a:chExt cx="308407" cy="2743570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B635D226-BE7B-5649-A785-01F4E7BE36D6}"/>
                </a:ext>
              </a:extLst>
            </p:cNvPr>
            <p:cNvSpPr txBox="1"/>
            <p:nvPr/>
          </p:nvSpPr>
          <p:spPr>
            <a:xfrm>
              <a:off x="1135593" y="2125412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1BC58BAA-4E3E-3646-B75D-ADD9E96B731B}"/>
                </a:ext>
              </a:extLst>
            </p:cNvPr>
            <p:cNvSpPr txBox="1"/>
            <p:nvPr/>
          </p:nvSpPr>
          <p:spPr>
            <a:xfrm>
              <a:off x="1135593" y="3000258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0C08A1D9-BD1A-7743-BAC7-0CE6648CFDBE}"/>
                </a:ext>
              </a:extLst>
            </p:cNvPr>
            <p:cNvSpPr txBox="1"/>
            <p:nvPr/>
          </p:nvSpPr>
          <p:spPr>
            <a:xfrm>
              <a:off x="1135593" y="3437681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ECF1CD2F-F089-CB42-9CCD-640BDBF47EFD}"/>
                </a:ext>
              </a:extLst>
            </p:cNvPr>
            <p:cNvSpPr txBox="1"/>
            <p:nvPr/>
          </p:nvSpPr>
          <p:spPr>
            <a:xfrm>
              <a:off x="1135593" y="4312527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4E60A201-F81F-794F-9CBD-6BA3567ADC30}"/>
                </a:ext>
              </a:extLst>
            </p:cNvPr>
            <p:cNvSpPr txBox="1"/>
            <p:nvPr/>
          </p:nvSpPr>
          <p:spPr>
            <a:xfrm>
              <a:off x="1135593" y="4749948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79A7C1F-6E0B-AB4F-9248-38B67431C9FA}"/>
                </a:ext>
              </a:extLst>
            </p:cNvPr>
            <p:cNvSpPr txBox="1"/>
            <p:nvPr/>
          </p:nvSpPr>
          <p:spPr>
            <a:xfrm>
              <a:off x="1135593" y="3875104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E82F1601-E3A8-C64A-B8A9-A959ABA04B1A}"/>
                </a:ext>
              </a:extLst>
            </p:cNvPr>
            <p:cNvSpPr txBox="1"/>
            <p:nvPr/>
          </p:nvSpPr>
          <p:spPr>
            <a:xfrm>
              <a:off x="1135593" y="2562835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ED0F082A-E322-E34F-8556-B6E70B8D5585}"/>
              </a:ext>
            </a:extLst>
          </p:cNvPr>
          <p:cNvGrpSpPr/>
          <p:nvPr/>
        </p:nvGrpSpPr>
        <p:grpSpPr>
          <a:xfrm>
            <a:off x="3225914" y="2988410"/>
            <a:ext cx="575718" cy="1926602"/>
            <a:chOff x="1536626" y="3080773"/>
            <a:chExt cx="530244" cy="1926602"/>
          </a:xfrm>
        </p:grpSpPr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165AC39-2329-1249-B275-08D3DD21457C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DH2</a:t>
              </a:r>
            </a:p>
          </p:txBody>
        </p: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BD4113E2-3F3D-5346-AF6A-880A4F7D0591}"/>
                </a:ext>
              </a:extLst>
            </p:cNvPr>
            <p:cNvGrpSpPr/>
            <p:nvPr/>
          </p:nvGrpSpPr>
          <p:grpSpPr>
            <a:xfrm>
              <a:off x="1660241" y="3080773"/>
              <a:ext cx="283015" cy="1719827"/>
              <a:chOff x="1669781" y="3080773"/>
              <a:chExt cx="283015" cy="1719827"/>
            </a:xfrm>
          </p:grpSpPr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72326BA9-3C75-B747-94EB-172C7AF5250B}"/>
                  </a:ext>
                </a:extLst>
              </p:cNvPr>
              <p:cNvGrpSpPr/>
              <p:nvPr/>
            </p:nvGrpSpPr>
            <p:grpSpPr>
              <a:xfrm>
                <a:off x="1669781" y="3690373"/>
                <a:ext cx="127559" cy="1110227"/>
                <a:chOff x="1669781" y="3690373"/>
                <a:chExt cx="127559" cy="1110227"/>
              </a:xfrm>
            </p:grpSpPr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E438E1A4-F4F5-4744-9141-A848ACF97CD0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8086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=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1/3</a:t>
                  </a:r>
                </a:p>
              </p:txBody>
            </p:sp>
            <p:sp>
              <p:nvSpPr>
                <p:cNvPr id="97" name="Rectangle 96">
                  <a:extLst>
                    <a:ext uri="{FF2B5EF4-FFF2-40B4-BE49-F238E27FC236}">
                      <a16:creationId xmlns:a16="http://schemas.microsoft.com/office/drawing/2014/main" id="{70FDEE7B-3692-EB4D-ACC2-84D99476A40F}"/>
                    </a:ext>
                  </a:extLst>
                </p:cNvPr>
                <p:cNvSpPr/>
                <p:nvPr/>
              </p:nvSpPr>
              <p:spPr>
                <a:xfrm>
                  <a:off x="1675960" y="4086225"/>
                  <a:ext cx="115200" cy="714375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D418E3D4-E2F7-5346-ADF2-00248A27B6D2}"/>
                  </a:ext>
                </a:extLst>
              </p:cNvPr>
              <p:cNvGrpSpPr/>
              <p:nvPr/>
            </p:nvGrpSpPr>
            <p:grpSpPr>
              <a:xfrm>
                <a:off x="1825237" y="3080773"/>
                <a:ext cx="127559" cy="1719827"/>
                <a:chOff x="1834762" y="3080773"/>
                <a:chExt cx="127559" cy="1719827"/>
              </a:xfrm>
            </p:grpSpPr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427C388D-631D-0F4B-87DD-688E0BD7B658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31990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5</a:t>
                  </a:r>
                </a:p>
              </p:txBody>
            </p:sp>
            <p:sp>
              <p:nvSpPr>
                <p:cNvPr id="95" name="Rectangle 94">
                  <a:extLst>
                    <a:ext uri="{FF2B5EF4-FFF2-40B4-BE49-F238E27FC236}">
                      <a16:creationId xmlns:a16="http://schemas.microsoft.com/office/drawing/2014/main" id="{E136D0FD-CC64-C14C-AB60-DB6C7D77E95B}"/>
                    </a:ext>
                  </a:extLst>
                </p:cNvPr>
                <p:cNvSpPr/>
                <p:nvPr/>
              </p:nvSpPr>
              <p:spPr>
                <a:xfrm>
                  <a:off x="1840941" y="3495675"/>
                  <a:ext cx="115200" cy="1304925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B277624F-73A3-1C46-9979-18E671927956}"/>
              </a:ext>
            </a:extLst>
          </p:cNvPr>
          <p:cNvGrpSpPr/>
          <p:nvPr/>
        </p:nvGrpSpPr>
        <p:grpSpPr>
          <a:xfrm>
            <a:off x="3811651" y="2528035"/>
            <a:ext cx="575718" cy="2386977"/>
            <a:chOff x="1536626" y="2620398"/>
            <a:chExt cx="530244" cy="2386977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C1C74B3-C06C-A341-B96F-A8D9C8239F4C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NMT3A</a:t>
              </a: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7B103AC7-E1B9-C345-98CD-E220AD0F72B5}"/>
                </a:ext>
              </a:extLst>
            </p:cNvPr>
            <p:cNvGrpSpPr/>
            <p:nvPr/>
          </p:nvGrpSpPr>
          <p:grpSpPr>
            <a:xfrm>
              <a:off x="1660241" y="2620398"/>
              <a:ext cx="283015" cy="2180203"/>
              <a:chOff x="1669781" y="2620398"/>
              <a:chExt cx="283015" cy="2180203"/>
            </a:xfrm>
          </p:grpSpPr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E9DC5DAE-7F11-4040-A1FD-04071DEC55F4}"/>
                  </a:ext>
                </a:extLst>
              </p:cNvPr>
              <p:cNvGrpSpPr/>
              <p:nvPr/>
            </p:nvGrpSpPr>
            <p:grpSpPr>
              <a:xfrm>
                <a:off x="1669781" y="3068073"/>
                <a:ext cx="127559" cy="1732528"/>
                <a:chOff x="1669781" y="3068073"/>
                <a:chExt cx="127559" cy="1732528"/>
              </a:xfrm>
            </p:grpSpPr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BD327342-B974-E344-BFEE-F0C50C2EFB07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1863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=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5</a:t>
                  </a:r>
                </a:p>
              </p:txBody>
            </p:sp>
            <p:sp>
              <p:nvSpPr>
                <p:cNvPr id="89" name="Rectangle 88">
                  <a:extLst>
                    <a:ext uri="{FF2B5EF4-FFF2-40B4-BE49-F238E27FC236}">
                      <a16:creationId xmlns:a16="http://schemas.microsoft.com/office/drawing/2014/main" id="{64738327-E388-814C-8844-9D83EF4BD70B}"/>
                    </a:ext>
                  </a:extLst>
                </p:cNvPr>
                <p:cNvSpPr/>
                <p:nvPr/>
              </p:nvSpPr>
              <p:spPr>
                <a:xfrm>
                  <a:off x="1675960" y="3498851"/>
                  <a:ext cx="115200" cy="1301750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7AD3676B-7F69-554D-A37D-0AB0BA55C564}"/>
                  </a:ext>
                </a:extLst>
              </p:cNvPr>
              <p:cNvGrpSpPr/>
              <p:nvPr/>
            </p:nvGrpSpPr>
            <p:grpSpPr>
              <a:xfrm>
                <a:off x="1825237" y="2620398"/>
                <a:ext cx="127559" cy="2180203"/>
                <a:chOff x="1834762" y="2620398"/>
                <a:chExt cx="127559" cy="2180203"/>
              </a:xfrm>
            </p:grpSpPr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23471026-45BD-5943-9E8E-E62964AB31D6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73867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4/5</a:t>
                  </a:r>
                </a:p>
              </p:txBody>
            </p:sp>
            <p:sp>
              <p:nvSpPr>
                <p:cNvPr id="87" name="Rectangle 86">
                  <a:extLst>
                    <a:ext uri="{FF2B5EF4-FFF2-40B4-BE49-F238E27FC236}">
                      <a16:creationId xmlns:a16="http://schemas.microsoft.com/office/drawing/2014/main" id="{98730EB2-3BDE-D542-8122-BD4B8DB30425}"/>
                    </a:ext>
                  </a:extLst>
                </p:cNvPr>
                <p:cNvSpPr/>
                <p:nvPr/>
              </p:nvSpPr>
              <p:spPr>
                <a:xfrm>
                  <a:off x="1840941" y="3060701"/>
                  <a:ext cx="115200" cy="1739900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EC4CE83D-61AF-744D-B98E-89B70AB5DA6D}"/>
              </a:ext>
            </a:extLst>
          </p:cNvPr>
          <p:cNvGrpSpPr/>
          <p:nvPr/>
        </p:nvGrpSpPr>
        <p:grpSpPr>
          <a:xfrm>
            <a:off x="4397387" y="2108935"/>
            <a:ext cx="575718" cy="2806077"/>
            <a:chOff x="1536626" y="2201298"/>
            <a:chExt cx="530244" cy="2806077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30008DF-357C-504E-A35C-17F8409B6880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P53</a:t>
              </a:r>
            </a:p>
          </p:txBody>
        </p: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87AD51D6-E22E-864B-A898-30C719A61F69}"/>
                </a:ext>
              </a:extLst>
            </p:cNvPr>
            <p:cNvGrpSpPr/>
            <p:nvPr/>
          </p:nvGrpSpPr>
          <p:grpSpPr>
            <a:xfrm>
              <a:off x="1660241" y="2201298"/>
              <a:ext cx="283015" cy="2599303"/>
              <a:chOff x="1669781" y="2201298"/>
              <a:chExt cx="283015" cy="2599303"/>
            </a:xfrm>
          </p:grpSpPr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DCE4B0C7-5213-FA4B-A908-B328CD4825F1}"/>
                  </a:ext>
                </a:extLst>
              </p:cNvPr>
              <p:cNvGrpSpPr/>
              <p:nvPr/>
            </p:nvGrpSpPr>
            <p:grpSpPr>
              <a:xfrm>
                <a:off x="1669781" y="2760098"/>
                <a:ext cx="127559" cy="2040502"/>
                <a:chOff x="1669781" y="2760098"/>
                <a:chExt cx="127559" cy="2040502"/>
              </a:xfrm>
            </p:grpSpPr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9202B1E8-2E66-CE44-8A95-4480233F587C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287837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4</a:t>
                  </a:r>
                </a:p>
              </p:txBody>
            </p:sp>
            <p:sp>
              <p:nvSpPr>
                <p:cNvPr id="81" name="Rectangle 80">
                  <a:extLst>
                    <a:ext uri="{FF2B5EF4-FFF2-40B4-BE49-F238E27FC236}">
                      <a16:creationId xmlns:a16="http://schemas.microsoft.com/office/drawing/2014/main" id="{668E2ADA-C79D-564F-B91D-A772C8EB51EC}"/>
                    </a:ext>
                  </a:extLst>
                </p:cNvPr>
                <p:cNvSpPr/>
                <p:nvPr/>
              </p:nvSpPr>
              <p:spPr>
                <a:xfrm>
                  <a:off x="1675960" y="3171825"/>
                  <a:ext cx="115200" cy="1628775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529048B0-E3B2-A24B-91DD-562D5FE65B33}"/>
                  </a:ext>
                </a:extLst>
              </p:cNvPr>
              <p:cNvGrpSpPr/>
              <p:nvPr/>
            </p:nvGrpSpPr>
            <p:grpSpPr>
              <a:xfrm>
                <a:off x="1825237" y="2201298"/>
                <a:ext cx="127559" cy="2599303"/>
                <a:chOff x="1834762" y="2201298"/>
                <a:chExt cx="127559" cy="2599303"/>
              </a:xfrm>
            </p:grpSpPr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1F41B4A5-F0F5-D04F-8C57-328F713E5226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31957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3</a:t>
                  </a:r>
                </a:p>
              </p:txBody>
            </p:sp>
            <p:sp>
              <p:nvSpPr>
                <p:cNvPr id="79" name="Rectangle 78">
                  <a:extLst>
                    <a:ext uri="{FF2B5EF4-FFF2-40B4-BE49-F238E27FC236}">
                      <a16:creationId xmlns:a16="http://schemas.microsoft.com/office/drawing/2014/main" id="{7ED1533B-2DBC-8143-B408-A3A351A1E67B}"/>
                    </a:ext>
                  </a:extLst>
                </p:cNvPr>
                <p:cNvSpPr/>
                <p:nvPr/>
              </p:nvSpPr>
              <p:spPr>
                <a:xfrm>
                  <a:off x="1840941" y="2619375"/>
                  <a:ext cx="115200" cy="2181226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ADF1232-D7C2-3040-8D48-3858CD53887D}"/>
              </a:ext>
            </a:extLst>
          </p:cNvPr>
          <p:cNvGrpSpPr/>
          <p:nvPr/>
        </p:nvGrpSpPr>
        <p:grpSpPr>
          <a:xfrm>
            <a:off x="4983124" y="2105760"/>
            <a:ext cx="575718" cy="2809252"/>
            <a:chOff x="1536626" y="2198123"/>
            <a:chExt cx="530244" cy="2809252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080CF0F-3EBC-7C40-8490-062035098E01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</a:p>
          </p:txBody>
        </p: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7CFB2EA7-7FAF-064B-BD7D-C4FE4B2F1745}"/>
                </a:ext>
              </a:extLst>
            </p:cNvPr>
            <p:cNvGrpSpPr/>
            <p:nvPr/>
          </p:nvGrpSpPr>
          <p:grpSpPr>
            <a:xfrm>
              <a:off x="1660241" y="2198123"/>
              <a:ext cx="283015" cy="2602478"/>
              <a:chOff x="1669781" y="2198123"/>
              <a:chExt cx="283015" cy="2602478"/>
            </a:xfrm>
          </p:grpSpPr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9CC1F57D-A093-1240-BE89-EC27A05E14F7}"/>
                  </a:ext>
                </a:extLst>
              </p:cNvPr>
              <p:cNvGrpSpPr/>
              <p:nvPr/>
            </p:nvGrpSpPr>
            <p:grpSpPr>
              <a:xfrm>
                <a:off x="1669781" y="3068073"/>
                <a:ext cx="127559" cy="1732528"/>
                <a:chOff x="1669781" y="3068073"/>
                <a:chExt cx="127559" cy="1732528"/>
              </a:xfrm>
            </p:grpSpPr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10E887EF-4883-1A45-9734-B05D9E22EE95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1863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5</a:t>
                  </a:r>
                </a:p>
              </p:txBody>
            </p:sp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089E67E8-1DF8-3F44-B77B-B124E46F7ACC}"/>
                    </a:ext>
                  </a:extLst>
                </p:cNvPr>
                <p:cNvSpPr/>
                <p:nvPr/>
              </p:nvSpPr>
              <p:spPr>
                <a:xfrm>
                  <a:off x="1675960" y="3498851"/>
                  <a:ext cx="115200" cy="1301750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1A765723-7075-634D-8264-3BFD160E52C7}"/>
                  </a:ext>
                </a:extLst>
              </p:cNvPr>
              <p:cNvGrpSpPr/>
              <p:nvPr/>
            </p:nvGrpSpPr>
            <p:grpSpPr>
              <a:xfrm>
                <a:off x="1825237" y="2198123"/>
                <a:ext cx="127559" cy="2602477"/>
                <a:chOff x="1834762" y="2198123"/>
                <a:chExt cx="127559" cy="2602477"/>
              </a:xfrm>
            </p:grpSpPr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2EEEE645-2ABB-4A4F-95E5-11899163D166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31639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5/5</a:t>
                  </a:r>
                </a:p>
              </p:txBody>
            </p:sp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D04C5D0E-1378-4F46-BF1D-3097943F481B}"/>
                    </a:ext>
                  </a:extLst>
                </p:cNvPr>
                <p:cNvSpPr/>
                <p:nvPr/>
              </p:nvSpPr>
              <p:spPr>
                <a:xfrm>
                  <a:off x="1840941" y="2619375"/>
                  <a:ext cx="115200" cy="2181225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04F9F9D-759F-4F41-B705-303AE2A9C5D6}"/>
              </a:ext>
            </a:extLst>
          </p:cNvPr>
          <p:cNvGrpSpPr/>
          <p:nvPr/>
        </p:nvGrpSpPr>
        <p:grpSpPr>
          <a:xfrm>
            <a:off x="5568861" y="2112110"/>
            <a:ext cx="575718" cy="2802902"/>
            <a:chOff x="1536626" y="2204473"/>
            <a:chExt cx="530244" cy="2802902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4470888-C8DC-BF43-AD9D-42801CB83A83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SXL1</a:t>
              </a:r>
            </a:p>
          </p:txBody>
        </p: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5B106486-1C38-6D43-A112-490C45AA2768}"/>
                </a:ext>
              </a:extLst>
            </p:cNvPr>
            <p:cNvGrpSpPr/>
            <p:nvPr/>
          </p:nvGrpSpPr>
          <p:grpSpPr>
            <a:xfrm>
              <a:off x="1660241" y="2204473"/>
              <a:ext cx="283015" cy="2596128"/>
              <a:chOff x="1669781" y="2204473"/>
              <a:chExt cx="283015" cy="2596128"/>
            </a:xfrm>
          </p:grpSpPr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714F8929-1312-0A47-BB7A-5B94F41CDE4D}"/>
                  </a:ext>
                </a:extLst>
              </p:cNvPr>
              <p:cNvGrpSpPr/>
              <p:nvPr/>
            </p:nvGrpSpPr>
            <p:grpSpPr>
              <a:xfrm>
                <a:off x="1669781" y="2725173"/>
                <a:ext cx="127559" cy="2075428"/>
                <a:chOff x="1669781" y="2725173"/>
                <a:chExt cx="127559" cy="2075428"/>
              </a:xfrm>
            </p:grpSpPr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BC713805-367D-D941-B887-16B89B077BCB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28434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4</a:t>
                  </a:r>
                </a:p>
              </p:txBody>
            </p:sp>
            <p:sp>
              <p:nvSpPr>
                <p:cNvPr id="65" name="Rectangle 64">
                  <a:extLst>
                    <a:ext uri="{FF2B5EF4-FFF2-40B4-BE49-F238E27FC236}">
                      <a16:creationId xmlns:a16="http://schemas.microsoft.com/office/drawing/2014/main" id="{279FFEFE-7540-4A4E-9433-8090FC2CA917}"/>
                    </a:ext>
                  </a:extLst>
                </p:cNvPr>
                <p:cNvSpPr/>
                <p:nvPr/>
              </p:nvSpPr>
              <p:spPr>
                <a:xfrm>
                  <a:off x="1675960" y="3175001"/>
                  <a:ext cx="115200" cy="1625600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24550617-AE17-0E4C-A5AC-579D23A52045}"/>
                  </a:ext>
                </a:extLst>
              </p:cNvPr>
              <p:cNvGrpSpPr/>
              <p:nvPr/>
            </p:nvGrpSpPr>
            <p:grpSpPr>
              <a:xfrm>
                <a:off x="1825237" y="2204473"/>
                <a:ext cx="127559" cy="2596127"/>
                <a:chOff x="1834762" y="2204473"/>
                <a:chExt cx="127559" cy="2596127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BDD77216-D1D1-4745-8643-49C3FCCBD07C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3227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 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3</a:t>
                  </a:r>
                </a:p>
              </p:txBody>
            </p:sp>
            <p:sp>
              <p:nvSpPr>
                <p:cNvPr id="63" name="Rectangle 62">
                  <a:extLst>
                    <a:ext uri="{FF2B5EF4-FFF2-40B4-BE49-F238E27FC236}">
                      <a16:creationId xmlns:a16="http://schemas.microsoft.com/office/drawing/2014/main" id="{F632C6B2-BFF6-3042-B6F9-0816E6E48EB5}"/>
                    </a:ext>
                  </a:extLst>
                </p:cNvPr>
                <p:cNvSpPr/>
                <p:nvPr/>
              </p:nvSpPr>
              <p:spPr>
                <a:xfrm>
                  <a:off x="1840941" y="2619375"/>
                  <a:ext cx="115200" cy="2181225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D7F3EDD-5B1E-7542-9456-3EF00B5980AA}"/>
              </a:ext>
            </a:extLst>
          </p:cNvPr>
          <p:cNvGrpSpPr/>
          <p:nvPr/>
        </p:nvGrpSpPr>
        <p:grpSpPr>
          <a:xfrm>
            <a:off x="6154597" y="2420085"/>
            <a:ext cx="575718" cy="2494927"/>
            <a:chOff x="1536626" y="2512448"/>
            <a:chExt cx="530244" cy="2494927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DD7AF75F-A104-E642-B213-D045B94F496D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RSF2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B163C088-009E-434A-B3C4-1948ABBAF368}"/>
                </a:ext>
              </a:extLst>
            </p:cNvPr>
            <p:cNvGrpSpPr/>
            <p:nvPr/>
          </p:nvGrpSpPr>
          <p:grpSpPr>
            <a:xfrm>
              <a:off x="1660241" y="2512448"/>
              <a:ext cx="283015" cy="2288153"/>
              <a:chOff x="1669781" y="2512448"/>
              <a:chExt cx="283015" cy="2288153"/>
            </a:xfrm>
          </p:grpSpPr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F998BE11-6E13-5643-896E-CF9FD79433CE}"/>
                  </a:ext>
                </a:extLst>
              </p:cNvPr>
              <p:cNvGrpSpPr/>
              <p:nvPr/>
            </p:nvGrpSpPr>
            <p:grpSpPr>
              <a:xfrm>
                <a:off x="1669781" y="3652273"/>
                <a:ext cx="127559" cy="1148327"/>
                <a:chOff x="1669781" y="3652273"/>
                <a:chExt cx="127559" cy="1148327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DF64C081-A64A-2948-86D7-814868D809C8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7705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1/3</a:t>
                  </a:r>
                </a:p>
              </p:txBody>
            </p:sp>
            <p:sp>
              <p:nvSpPr>
                <p:cNvPr id="57" name="Rectangle 56">
                  <a:extLst>
                    <a:ext uri="{FF2B5EF4-FFF2-40B4-BE49-F238E27FC236}">
                      <a16:creationId xmlns:a16="http://schemas.microsoft.com/office/drawing/2014/main" id="{E704477C-AC88-EA47-A996-02E2AD39756F}"/>
                    </a:ext>
                  </a:extLst>
                </p:cNvPr>
                <p:cNvSpPr/>
                <p:nvPr/>
              </p:nvSpPr>
              <p:spPr>
                <a:xfrm>
                  <a:off x="1675960" y="4092575"/>
                  <a:ext cx="115200" cy="708025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AA39CC80-3A94-8941-A10D-EDF28358AD12}"/>
                  </a:ext>
                </a:extLst>
              </p:cNvPr>
              <p:cNvGrpSpPr/>
              <p:nvPr/>
            </p:nvGrpSpPr>
            <p:grpSpPr>
              <a:xfrm>
                <a:off x="1825237" y="2512448"/>
                <a:ext cx="127559" cy="2288153"/>
                <a:chOff x="1834762" y="2512448"/>
                <a:chExt cx="127559" cy="2288153"/>
              </a:xfrm>
            </p:grpSpPr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084538E-B7E2-B849-A8A8-F4F1569DB14B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63072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6/7</a:t>
                  </a:r>
                </a:p>
              </p:txBody>
            </p:sp>
            <p:sp>
              <p:nvSpPr>
                <p:cNvPr id="55" name="Rectangle 54">
                  <a:extLst>
                    <a:ext uri="{FF2B5EF4-FFF2-40B4-BE49-F238E27FC236}">
                      <a16:creationId xmlns:a16="http://schemas.microsoft.com/office/drawing/2014/main" id="{72EE0F30-3168-F949-84B8-241F39D57A22}"/>
                    </a:ext>
                  </a:extLst>
                </p:cNvPr>
                <p:cNvSpPr/>
                <p:nvPr/>
              </p:nvSpPr>
              <p:spPr>
                <a:xfrm>
                  <a:off x="1840941" y="2933701"/>
                  <a:ext cx="115200" cy="1866900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6DEA58B-6EAD-A144-AF43-249F764B6135}"/>
              </a:ext>
            </a:extLst>
          </p:cNvPr>
          <p:cNvGrpSpPr/>
          <p:nvPr/>
        </p:nvGrpSpPr>
        <p:grpSpPr>
          <a:xfrm>
            <a:off x="6740334" y="2667735"/>
            <a:ext cx="575718" cy="2247277"/>
            <a:chOff x="1536626" y="2760098"/>
            <a:chExt cx="530244" cy="2247277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C966178-90CF-614F-A4E3-5C48D8130B7F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UNX1</a:t>
              </a:r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51FAB9CA-973F-8946-B22A-EB4FD6F17319}"/>
                </a:ext>
              </a:extLst>
            </p:cNvPr>
            <p:cNvGrpSpPr/>
            <p:nvPr/>
          </p:nvGrpSpPr>
          <p:grpSpPr>
            <a:xfrm>
              <a:off x="1660241" y="2760098"/>
              <a:ext cx="283015" cy="2040503"/>
              <a:chOff x="1669781" y="2760098"/>
              <a:chExt cx="283015" cy="2040503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75EB3167-8997-C343-B648-0A89F20A08FB}"/>
                  </a:ext>
                </a:extLst>
              </p:cNvPr>
              <p:cNvGrpSpPr/>
              <p:nvPr/>
            </p:nvGrpSpPr>
            <p:grpSpPr>
              <a:xfrm>
                <a:off x="1669781" y="2922023"/>
                <a:ext cx="127559" cy="1878578"/>
                <a:chOff x="1669781" y="2922023"/>
                <a:chExt cx="127559" cy="1878578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764B19DD-2D01-3E45-A025-78C2B6B2FC80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04029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4/6</a:t>
                  </a:r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588AE11E-A158-2D40-824F-785E27F975AA}"/>
                    </a:ext>
                  </a:extLst>
                </p:cNvPr>
                <p:cNvSpPr/>
                <p:nvPr/>
              </p:nvSpPr>
              <p:spPr>
                <a:xfrm>
                  <a:off x="1675960" y="3346451"/>
                  <a:ext cx="115200" cy="1454150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59032973-691A-C447-863E-E9F9E4FCEA54}"/>
                  </a:ext>
                </a:extLst>
              </p:cNvPr>
              <p:cNvGrpSpPr/>
              <p:nvPr/>
            </p:nvGrpSpPr>
            <p:grpSpPr>
              <a:xfrm>
                <a:off x="1825237" y="2760098"/>
                <a:ext cx="127559" cy="2040502"/>
                <a:chOff x="1834762" y="2760098"/>
                <a:chExt cx="127559" cy="2040502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1089FA90-A693-F241-AA83-080C2CAFCF7A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87837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4</a:t>
                  </a:r>
                </a:p>
              </p:txBody>
            </p: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B9216053-5950-C04E-9EF2-7B78E6157C93}"/>
                    </a:ext>
                  </a:extLst>
                </p:cNvPr>
                <p:cNvSpPr/>
                <p:nvPr/>
              </p:nvSpPr>
              <p:spPr>
                <a:xfrm>
                  <a:off x="1840941" y="3165475"/>
                  <a:ext cx="115200" cy="1635125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80439EC-5879-E841-AB2D-D5FB5D36D1F2}"/>
              </a:ext>
            </a:extLst>
          </p:cNvPr>
          <p:cNvGrpSpPr/>
          <p:nvPr/>
        </p:nvGrpSpPr>
        <p:grpSpPr>
          <a:xfrm>
            <a:off x="7326071" y="2661385"/>
            <a:ext cx="575718" cy="2253627"/>
            <a:chOff x="1536626" y="2753748"/>
            <a:chExt cx="530244" cy="2253627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E32279A-4B1C-034D-AB76-66FD099EF912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G2</a:t>
              </a: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60CC71C5-03D9-2E44-8BFE-470C4F5A3592}"/>
                </a:ext>
              </a:extLst>
            </p:cNvPr>
            <p:cNvGrpSpPr/>
            <p:nvPr/>
          </p:nvGrpSpPr>
          <p:grpSpPr>
            <a:xfrm>
              <a:off x="1660241" y="2753748"/>
              <a:ext cx="283015" cy="2046852"/>
              <a:chOff x="1669781" y="2753748"/>
              <a:chExt cx="283015" cy="2046852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B1C32803-8D40-6B48-8DA7-0545E12F438D}"/>
                  </a:ext>
                </a:extLst>
              </p:cNvPr>
              <p:cNvGrpSpPr/>
              <p:nvPr/>
            </p:nvGrpSpPr>
            <p:grpSpPr>
              <a:xfrm>
                <a:off x="1669781" y="3852298"/>
                <a:ext cx="127559" cy="948302"/>
                <a:chOff x="1669781" y="3852298"/>
                <a:chExt cx="127559" cy="948302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80DBF4A0-09A4-904B-8D23-4B393736C335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97057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1/4</a:t>
                  </a:r>
                </a:p>
              </p:txBody>
            </p:sp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4C8DFC95-F65F-2D45-B8BE-C8977E2CC4BD}"/>
                    </a:ext>
                  </a:extLst>
                </p:cNvPr>
                <p:cNvSpPr/>
                <p:nvPr/>
              </p:nvSpPr>
              <p:spPr>
                <a:xfrm>
                  <a:off x="1675960" y="4267200"/>
                  <a:ext cx="115200" cy="533400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D8FCF904-B6A1-CC4D-AB6B-D7D88999E811}"/>
                  </a:ext>
                </a:extLst>
              </p:cNvPr>
              <p:cNvGrpSpPr/>
              <p:nvPr/>
            </p:nvGrpSpPr>
            <p:grpSpPr>
              <a:xfrm>
                <a:off x="1825237" y="2753748"/>
                <a:ext cx="127559" cy="2046852"/>
                <a:chOff x="1834762" y="2753748"/>
                <a:chExt cx="127559" cy="2046852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5108E0D0-1D9D-1147-883E-F752B5A1CB83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87202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 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4</a:t>
                  </a:r>
                </a:p>
              </p:txBody>
            </p:sp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26E68B0F-0438-2044-BAC2-9F72C1A7489D}"/>
                    </a:ext>
                  </a:extLst>
                </p:cNvPr>
                <p:cNvSpPr/>
                <p:nvPr/>
              </p:nvSpPr>
              <p:spPr>
                <a:xfrm>
                  <a:off x="1840941" y="3165475"/>
                  <a:ext cx="115200" cy="1635125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818D163-60C3-8F42-9146-15BC8079E03F}"/>
              </a:ext>
            </a:extLst>
          </p:cNvPr>
          <p:cNvGrpSpPr/>
          <p:nvPr/>
        </p:nvGrpSpPr>
        <p:grpSpPr>
          <a:xfrm>
            <a:off x="7911808" y="2112110"/>
            <a:ext cx="575718" cy="2802902"/>
            <a:chOff x="1536626" y="2204473"/>
            <a:chExt cx="530244" cy="2802902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0A57291-930C-944A-9012-E2311CC85C4C}"/>
                </a:ext>
              </a:extLst>
            </p:cNvPr>
            <p:cNvSpPr txBox="1"/>
            <p:nvPr/>
          </p:nvSpPr>
          <p:spPr>
            <a:xfrm>
              <a:off x="1536626" y="4853487"/>
              <a:ext cx="530244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RO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U2AF1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34A8BB07-6E0A-FA43-A779-DF7144541654}"/>
                </a:ext>
              </a:extLst>
            </p:cNvPr>
            <p:cNvGrpSpPr/>
            <p:nvPr/>
          </p:nvGrpSpPr>
          <p:grpSpPr>
            <a:xfrm>
              <a:off x="1660241" y="2204473"/>
              <a:ext cx="283015" cy="2596127"/>
              <a:chOff x="1669781" y="2204473"/>
              <a:chExt cx="283015" cy="2596127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8541EC35-28AB-404A-9E4E-735630EDACC8}"/>
                  </a:ext>
                </a:extLst>
              </p:cNvPr>
              <p:cNvGrpSpPr/>
              <p:nvPr/>
            </p:nvGrpSpPr>
            <p:grpSpPr>
              <a:xfrm>
                <a:off x="1669781" y="3077598"/>
                <a:ext cx="127559" cy="1723002"/>
                <a:chOff x="1669781" y="3077598"/>
                <a:chExt cx="127559" cy="1723002"/>
              </a:xfrm>
            </p:grpSpPr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3CC28B41-F9F1-FC41-8554-E2F089F76484}"/>
                    </a:ext>
                  </a:extLst>
                </p:cNvPr>
                <p:cNvSpPr txBox="1"/>
                <p:nvPr/>
              </p:nvSpPr>
              <p:spPr>
                <a:xfrm rot="16200000">
                  <a:off x="1551508" y="3195871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/5</a:t>
                  </a:r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3DE48A8F-9C0C-7F47-8014-005265C18CBC}"/>
                    </a:ext>
                  </a:extLst>
                </p:cNvPr>
                <p:cNvSpPr/>
                <p:nvPr/>
              </p:nvSpPr>
              <p:spPr>
                <a:xfrm>
                  <a:off x="1675960" y="3495675"/>
                  <a:ext cx="115200" cy="1304925"/>
                </a:xfrm>
                <a:prstGeom prst="rect">
                  <a:avLst/>
                </a:prstGeom>
                <a:solidFill>
                  <a:schemeClr val="tx1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59D03698-152B-AC40-96D6-72867B434046}"/>
                  </a:ext>
                </a:extLst>
              </p:cNvPr>
              <p:cNvGrpSpPr/>
              <p:nvPr/>
            </p:nvGrpSpPr>
            <p:grpSpPr>
              <a:xfrm>
                <a:off x="1825237" y="2204473"/>
                <a:ext cx="127559" cy="2596127"/>
                <a:chOff x="1834762" y="2204473"/>
                <a:chExt cx="127559" cy="2596127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F6554E03-636D-CD4A-B798-0AAC3673E2CD}"/>
                    </a:ext>
                  </a:extLst>
                </p:cNvPr>
                <p:cNvSpPr txBox="1"/>
                <p:nvPr/>
              </p:nvSpPr>
              <p:spPr>
                <a:xfrm rot="16200000">
                  <a:off x="1716489" y="2322746"/>
                  <a:ext cx="364105" cy="12755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900" b="0" i="1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kumimoji="0" lang="en-GB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=</a:t>
                  </a:r>
                  <a:r>
                    <a:rPr kumimoji="0" lang="en-RO" sz="900" b="0" i="0" u="none" strike="noStrike" kern="0" cap="none" spc="0" normalizeH="0" baseline="0" noProof="0" dirty="0" smtClean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0" lang="en-RO" sz="9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6/6</a:t>
                  </a:r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EFA53BC9-5FF9-E14A-ACE0-5048DC68CEBA}"/>
                    </a:ext>
                  </a:extLst>
                </p:cNvPr>
                <p:cNvSpPr/>
                <p:nvPr/>
              </p:nvSpPr>
              <p:spPr>
                <a:xfrm>
                  <a:off x="1840941" y="2619375"/>
                  <a:ext cx="115200" cy="2181225"/>
                </a:xfrm>
                <a:prstGeom prst="rect">
                  <a:avLst/>
                </a:prstGeom>
                <a:solidFill>
                  <a:srgbClr val="E60004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RO" sz="1800" b="0" i="0" u="none" strike="noStrike" kern="0" cap="none" spc="0" normalizeH="0" baseline="0" noProof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72978E4F-F2B2-504B-9651-80A8139091AC}"/>
              </a:ext>
            </a:extLst>
          </p:cNvPr>
          <p:cNvGrpSpPr/>
          <p:nvPr/>
        </p:nvGrpSpPr>
        <p:grpSpPr>
          <a:xfrm>
            <a:off x="4595585" y="4966622"/>
            <a:ext cx="2511313" cy="138500"/>
            <a:chOff x="1946494" y="5223877"/>
            <a:chExt cx="2312951" cy="138500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E770CECA-0440-F644-B93E-60FCC529613C}"/>
                </a:ext>
              </a:extLst>
            </p:cNvPr>
            <p:cNvGrpSpPr/>
            <p:nvPr/>
          </p:nvGrpSpPr>
          <p:grpSpPr>
            <a:xfrm>
              <a:off x="1946494" y="5223878"/>
              <a:ext cx="714861" cy="138499"/>
              <a:chOff x="1946494" y="5223878"/>
              <a:chExt cx="714861" cy="138499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A9AF3BE-433B-D046-87F2-48AAB56EAB3F}"/>
                  </a:ext>
                </a:extLst>
              </p:cNvPr>
              <p:cNvSpPr txBox="1"/>
              <p:nvPr/>
            </p:nvSpPr>
            <p:spPr>
              <a:xfrm>
                <a:off x="2050677" y="5223878"/>
                <a:ext cx="610678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900" b="0" i="0" u="none" strike="noStrike" kern="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zacitidine</a:t>
                </a:r>
                <a:endParaRPr kumimoji="0" lang="en-RO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7302D315-5DD1-9F49-ADFC-B3AD89B89DF7}"/>
                  </a:ext>
                </a:extLst>
              </p:cNvPr>
              <p:cNvSpPr/>
              <p:nvPr/>
            </p:nvSpPr>
            <p:spPr>
              <a:xfrm>
                <a:off x="1946494" y="5248920"/>
                <a:ext cx="73025" cy="73025"/>
              </a:xfrm>
              <a:prstGeom prst="rect">
                <a:avLst/>
              </a:prstGeom>
              <a:solidFill>
                <a:schemeClr val="tx1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RO" sz="18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C6340490-6BE8-6145-B79B-431206098281}"/>
                </a:ext>
              </a:extLst>
            </p:cNvPr>
            <p:cNvGrpSpPr/>
            <p:nvPr/>
          </p:nvGrpSpPr>
          <p:grpSpPr>
            <a:xfrm>
              <a:off x="2708519" y="5223877"/>
              <a:ext cx="1550926" cy="138499"/>
              <a:chOff x="2956169" y="5223877"/>
              <a:chExt cx="1550926" cy="138499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80C0445-DE63-CB4D-BE81-68E210F9D98E}"/>
                  </a:ext>
                </a:extLst>
              </p:cNvPr>
              <p:cNvSpPr txBox="1"/>
              <p:nvPr/>
            </p:nvSpPr>
            <p:spPr>
              <a:xfrm>
                <a:off x="2956169" y="5223877"/>
                <a:ext cx="1550926" cy="1384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900" b="0" i="0" u="none" strike="noStrike" kern="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evonedistat + azacitidine</a:t>
                </a:r>
                <a:endParaRPr kumimoji="0" lang="en-RO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EB87673F-B52A-554B-8628-E1C3C5AF21C2}"/>
                  </a:ext>
                </a:extLst>
              </p:cNvPr>
              <p:cNvSpPr/>
              <p:nvPr/>
            </p:nvSpPr>
            <p:spPr>
              <a:xfrm>
                <a:off x="3010852" y="5248920"/>
                <a:ext cx="73025" cy="73025"/>
              </a:xfrm>
              <a:prstGeom prst="rect">
                <a:avLst/>
              </a:prstGeom>
              <a:solidFill>
                <a:srgbClr val="E60004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RO" sz="1800" b="0" i="0" u="none" strike="noStrike" kern="0" cap="none" spc="0" normalizeH="0" baseline="0" noProof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5DD46B2F-5360-3543-B05C-74F37055026B}"/>
              </a:ext>
            </a:extLst>
          </p:cNvPr>
          <p:cNvGrpSpPr/>
          <p:nvPr/>
        </p:nvGrpSpPr>
        <p:grpSpPr>
          <a:xfrm>
            <a:off x="3212285" y="2082037"/>
            <a:ext cx="5237711" cy="2635200"/>
            <a:chOff x="2453843" y="3084801"/>
            <a:chExt cx="3591407" cy="2099946"/>
          </a:xfrm>
        </p:grpSpPr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1515A830-AC78-EC40-A148-9009AD7E2261}"/>
                </a:ext>
              </a:extLst>
            </p:cNvPr>
            <p:cNvCxnSpPr>
              <a:cxnSpLocks/>
            </p:cNvCxnSpPr>
            <p:nvPr/>
          </p:nvCxnSpPr>
          <p:spPr>
            <a:xfrm>
              <a:off x="2456524" y="3084801"/>
              <a:ext cx="0" cy="2099946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6A4AE30B-FD67-D743-95BB-AA550AE573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53843" y="5183372"/>
              <a:ext cx="3591407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</p:grpSp>
      <p:sp>
        <p:nvSpPr>
          <p:cNvPr id="112" name="TextBox 111">
            <a:extLst>
              <a:ext uri="{FF2B5EF4-FFF2-40B4-BE49-F238E27FC236}">
                <a16:creationId xmlns:a16="http://schemas.microsoft.com/office/drawing/2014/main" id="{052997DB-1A9C-FD4D-976A-4B27E5580FCA}"/>
              </a:ext>
            </a:extLst>
          </p:cNvPr>
          <p:cNvSpPr txBox="1"/>
          <p:nvPr/>
        </p:nvSpPr>
        <p:spPr>
          <a:xfrm rot="16200000">
            <a:off x="1775238" y="3320551"/>
            <a:ext cx="1995752" cy="246221"/>
          </a:xfrm>
          <a:prstGeom prst="rect">
            <a:avLst/>
          </a:prstGeom>
          <a:noFill/>
        </p:spPr>
        <p:txBody>
          <a:bodyPr wrap="none" lIns="0" rIns="0" rtlCol="0">
            <a:no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atients (%)</a:t>
            </a:r>
            <a:endParaRPr lang="en-RO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"/>
          <p:cNvSpPr txBox="1"/>
          <p:nvPr/>
        </p:nvSpPr>
        <p:spPr>
          <a:xfrm>
            <a:off x="10543" y="8516"/>
            <a:ext cx="18507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0</a:t>
            </a:r>
            <a:endParaRPr lang="en-US" sz="1100" dirty="0">
              <a:solidFill>
                <a:srgbClr val="45434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1304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7</cp:revision>
  <dcterms:created xsi:type="dcterms:W3CDTF">2020-06-03T10:44:43Z</dcterms:created>
  <dcterms:modified xsi:type="dcterms:W3CDTF">2020-08-25T16:00:09Z</dcterms:modified>
</cp:coreProperties>
</file>